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78"/>
    <p:restoredTop sz="96405"/>
  </p:normalViewPr>
  <p:slideViewPr>
    <p:cSldViewPr snapToGrid="0" snapToObjects="1">
      <p:cViewPr varScale="1">
        <p:scale>
          <a:sx n="74" d="100"/>
          <a:sy n="74" d="100"/>
        </p:scale>
        <p:origin x="66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C8081CF-85E4-F441-9252-A080238E3E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1719924E-750B-0F41-8AAE-C02CA667D9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92916F9-CA49-6B41-BB89-7C9E4B8365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E42EFE8D-E077-E74F-A1A3-A7C407924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234C8AB-7ACA-D74F-A68C-FE454E45F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1373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28E32ED-D1EA-1645-BE92-8027C7A98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30A76D05-99A9-F843-B14A-AA90D79692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0365F86-E3BE-0141-AC5D-AB77B4073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17A96B1F-A790-3044-A563-F4F99D2DC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FD6F6F8-6261-DC48-ABF5-4307991E8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6252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01759BC1-3A91-0447-A6AB-377BC4E779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6F401301-7523-024E-8CF9-C15841808E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5B35AD0-223C-C04D-B85B-F82F99CBB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17226CF-934D-0E4F-A55D-450E46B06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378B2FE-DFC9-5B45-9F5F-4E02E7737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645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CFE7F81-35A9-1341-B854-4490FC0DD1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10728CA0-DAE8-2A48-8E8A-4572CE92C2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DD8A65F-CBF5-0640-8566-5C8E92D00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90293EA-FB91-354B-A941-B27F874A9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3D0C55A-2F4E-AA4D-964B-A3A052D24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708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E00D52B-AD77-E34D-8EF6-83C8AC0224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CA8EB39-5840-B742-A3FA-4F4D17D8FC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26CB8EF-35DD-D249-B86B-9AF8944E98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87E210B-1E9A-B342-9572-FCED86E7DE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A3604B04-C605-4748-8130-049205F8B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9524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5D5AE3E-8B93-A94F-AD29-091DAFA29B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BE4971E-0ADF-A144-9816-6C27C78CA4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237E11AE-4AB3-AE40-A606-604688C52A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E31DEA9D-FAA7-8547-B3C7-A5BB45967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809B8A52-E263-9644-A128-2BF144236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C08B9081-82A9-F949-911A-1C76884AC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2179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6D94AE1-FF24-8649-A480-8424D7018D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284DAB48-2CD3-974A-B870-3DBBF66A1B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233BF00B-8B2A-824B-96BD-BEC5C3928F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009AD2AF-7F26-8F41-BF42-097F1242EF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788C5FB2-4662-A246-B633-534B56CB9F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7BC9B9AF-0F90-8F4C-A8C4-46759EF5A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752E958A-27B6-3D41-9AAF-4512E97DE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AA037549-BA4B-BF4A-ADAF-34256E186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8295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90467AE-AF12-C840-B452-7138D2410F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E770492F-8756-374F-B54C-F2C982D5F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5860ADC6-7BFF-944B-B787-2FAFF46AB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959F98FB-76C2-6440-81DA-E5A8AA5A2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2763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DFE6B0CA-0EA2-6B4F-A243-74BEB5BD7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9DC48885-6DBD-C946-A6C3-BBE94CC3D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1D22AB91-D4CE-4D49-A443-E7362950A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121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393FE95-BE17-5340-A078-33486855B3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7F5C08FD-CC2A-B046-806D-6BA3983F3E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4A84B1E4-17E2-4749-A7A0-285B89E8B7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3E4CE1C5-0D0F-F242-B657-AA5898DF2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A3A0BFC4-1CE3-3D4D-B3D0-669F7976B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5438DF4E-77A9-9744-9A21-8FA1997B7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4215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4631D1B-3B28-C644-82E2-DB5702ABB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9527729E-7156-434E-B9FA-C07136FF53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ED21B795-CAC2-FF48-8168-D38ABEF933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E2B42299-190B-6142-9B0A-BEB0583E0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682D5D49-03F1-5947-82D0-381D15FA7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B0C5E4C6-7C6E-9A4A-AE48-2B2757A86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1198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136A1AD3-32D9-8242-AA7F-6E7DA783E4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29FDB5F-4CE5-AD49-B0DA-FAC78DCEBD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5C058B3-B6F1-B844-A774-FD9A99CEDE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61FA0F-C75E-464A-BBAC-08413FE1A59B}" type="datetimeFigureOut">
              <a:rPr kumimoji="1" lang="ja-JP" altLang="en-US" smtClean="0"/>
              <a:t>2024/6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2E510C0-67A7-994C-9F33-4506442695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27A3CA1-9A74-0749-BEDC-44621B482A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4CBF74-DF81-F843-AF4B-2D100DCD5E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217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jpe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図 4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19687" y="1093550"/>
            <a:ext cx="2520697" cy="1522500"/>
          </a:xfrm>
          <a:prstGeom prst="rect">
            <a:avLst/>
          </a:prstGeom>
        </p:spPr>
      </p:pic>
      <p:pic>
        <p:nvPicPr>
          <p:cNvPr id="74" name="図 7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41454" y="4268876"/>
            <a:ext cx="2563966" cy="1538380"/>
          </a:xfrm>
          <a:prstGeom prst="rect">
            <a:avLst/>
          </a:prstGeom>
        </p:spPr>
      </p:pic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1CBEE0DF-0D07-9265-43CA-EC615780BB9F}"/>
              </a:ext>
            </a:extLst>
          </p:cNvPr>
          <p:cNvSpPr txBox="1"/>
          <p:nvPr/>
        </p:nvSpPr>
        <p:spPr>
          <a:xfrm rot="20613699">
            <a:off x="1757287" y="609749"/>
            <a:ext cx="34050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i="1" dirty="0">
                <a:solidFill>
                  <a:srgbClr val="C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Older </a:t>
            </a:r>
            <a:r>
              <a:rPr kumimoji="1" lang="en-US" altLang="ja-JP" sz="3200" b="1" i="1" dirty="0">
                <a:latin typeface="Meiryo UI" panose="020B0604030504040204" pitchFamily="50" charset="-128"/>
                <a:ea typeface="Meiryo UI" panose="020B0604030504040204" pitchFamily="50" charset="-128"/>
              </a:rPr>
              <a:t>CVD</a:t>
            </a:r>
            <a:r>
              <a:rPr kumimoji="1" lang="en-US" altLang="ja-JP" sz="3200" b="1" i="1" dirty="0">
                <a:solidFill>
                  <a:srgbClr val="C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 </a:t>
            </a:r>
            <a:r>
              <a:rPr kumimoji="1" lang="en-US" altLang="ja-JP" sz="1600" b="1" i="1" dirty="0">
                <a:solidFill>
                  <a:srgbClr val="C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atients</a:t>
            </a:r>
            <a:endParaRPr kumimoji="1" lang="ja-JP" altLang="en-US" sz="1600" b="1" i="1" dirty="0">
              <a:solidFill>
                <a:srgbClr val="C000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1F318370-5971-DC25-ADEA-291867BCC77C}"/>
              </a:ext>
            </a:extLst>
          </p:cNvPr>
          <p:cNvSpPr txBox="1"/>
          <p:nvPr/>
        </p:nvSpPr>
        <p:spPr>
          <a:xfrm>
            <a:off x="1527894" y="5663282"/>
            <a:ext cx="8722777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2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The high SB group comprised </a:t>
            </a:r>
            <a:r>
              <a:rPr lang="en-US" altLang="ja-JP" sz="1400" b="1" i="1" u="sng" dirty="0">
                <a:solidFill>
                  <a:srgbClr val="C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48.5%</a:t>
            </a:r>
            <a:r>
              <a:rPr lang="en-US" altLang="ja-JP" sz="14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 </a:t>
            </a:r>
            <a:r>
              <a:rPr lang="en-US" altLang="ja-JP" sz="12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of older CVD patients in phase I C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2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The results showed that GS was lower and FTSST was higher in the high SB group than in the low SB group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200" i="1" dirty="0">
                <a:latin typeface="Meiryo UI" panose="020B0604030504040204" pitchFamily="50" charset="-128"/>
                <a:ea typeface="Meiryo UI" panose="020B0604030504040204" pitchFamily="50" charset="-128"/>
              </a:rPr>
              <a:t>Motor, cognitive, and total FIM scores were significantly lower in the high SB group than in the low SB </a:t>
            </a:r>
            <a:r>
              <a:rPr lang="en-US" altLang="ja-JP" sz="1200" i="1" dirty="0" smtClean="0">
                <a:latin typeface="Meiryo UI" panose="020B0604030504040204" pitchFamily="50" charset="-128"/>
                <a:ea typeface="Meiryo UI" panose="020B0604030504040204" pitchFamily="50" charset="-128"/>
              </a:rPr>
              <a:t>group. </a:t>
            </a:r>
            <a:r>
              <a:rPr lang="en-GB" sz="1200" i="1" dirty="0"/>
              <a:t>CR</a:t>
            </a:r>
            <a:r>
              <a:rPr lang="en-GB" sz="1200" dirty="0"/>
              <a:t> cardiac rehabilitation, </a:t>
            </a:r>
            <a:r>
              <a:rPr lang="en-GB" sz="1200" i="1" dirty="0"/>
              <a:t>CVD</a:t>
            </a:r>
            <a:r>
              <a:rPr lang="en-GB" sz="1200" dirty="0"/>
              <a:t> cardiovascular disease, </a:t>
            </a:r>
            <a:r>
              <a:rPr lang="en-GB" sz="1200" i="1" dirty="0"/>
              <a:t>FIM</a:t>
            </a:r>
            <a:r>
              <a:rPr lang="en-GB" sz="1200" dirty="0"/>
              <a:t> Functional Independence Measure, </a:t>
            </a:r>
            <a:r>
              <a:rPr lang="en-GB" sz="1200" i="1" dirty="0"/>
              <a:t>FITTS</a:t>
            </a:r>
            <a:r>
              <a:rPr lang="en-GB" sz="1200" dirty="0"/>
              <a:t> Five Times Sit to Stand Test, </a:t>
            </a:r>
            <a:r>
              <a:rPr lang="en-GB" sz="1200" i="1" dirty="0"/>
              <a:t>GS</a:t>
            </a:r>
            <a:r>
              <a:rPr lang="en-GB" sz="1200" dirty="0"/>
              <a:t> gait speed, </a:t>
            </a:r>
            <a:r>
              <a:rPr lang="en-GB" sz="1200" i="1" dirty="0"/>
              <a:t>SB</a:t>
            </a:r>
            <a:r>
              <a:rPr lang="en-GB" sz="1200" dirty="0"/>
              <a:t> sedentary behaviour</a:t>
            </a:r>
            <a:r>
              <a:rPr lang="en-US" altLang="ja-JP" sz="1200" i="1" dirty="0" smtClean="0">
                <a:latin typeface="Meiryo UI" panose="020B0604030504040204" pitchFamily="50" charset="-128"/>
                <a:ea typeface="Meiryo UI" panose="020B0604030504040204" pitchFamily="50" charset="-128"/>
              </a:rPr>
              <a:t> </a:t>
            </a:r>
            <a:endParaRPr kumimoji="1" lang="en-US" altLang="ja-JP" sz="1200" i="1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18605" y="477228"/>
            <a:ext cx="368118" cy="531963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xmlns="" id="{381707AD-081A-CC3E-6D38-B40F96A443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43701" y="4586029"/>
            <a:ext cx="664374" cy="664374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1A863D35-8F51-C2AE-3308-C2B2D6AEFCCB}"/>
              </a:ext>
            </a:extLst>
          </p:cNvPr>
          <p:cNvSpPr txBox="1"/>
          <p:nvPr/>
        </p:nvSpPr>
        <p:spPr>
          <a:xfrm rot="20656239">
            <a:off x="8269482" y="394411"/>
            <a:ext cx="2447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b="1" i="1" dirty="0">
                <a:solidFill>
                  <a:srgbClr val="C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hysical outcomes</a:t>
            </a:r>
            <a:endParaRPr kumimoji="1" lang="ja-JP" altLang="en-US" sz="1400" b="1" i="1" dirty="0">
              <a:solidFill>
                <a:srgbClr val="C000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1A863D35-8F51-C2AE-3308-C2B2D6AEFCCB}"/>
              </a:ext>
            </a:extLst>
          </p:cNvPr>
          <p:cNvSpPr txBox="1"/>
          <p:nvPr/>
        </p:nvSpPr>
        <p:spPr>
          <a:xfrm rot="20655363">
            <a:off x="1739211" y="4003393"/>
            <a:ext cx="28884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b="1" i="1" dirty="0">
                <a:solidFill>
                  <a:srgbClr val="C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S</a:t>
            </a:r>
            <a:r>
              <a:rPr kumimoji="1" lang="en-US" altLang="ja-JP" sz="1400" b="1" i="1" dirty="0">
                <a:solidFill>
                  <a:srgbClr val="C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edentary behavior time</a:t>
            </a:r>
            <a:endParaRPr kumimoji="1" lang="ja-JP" altLang="en-US" sz="1400" b="1" i="1" dirty="0">
              <a:solidFill>
                <a:srgbClr val="C000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graphicFrame>
        <p:nvGraphicFramePr>
          <p:cNvPr id="28" name="表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1831286"/>
              </p:ext>
            </p:extLst>
          </p:nvPr>
        </p:nvGraphicFramePr>
        <p:xfrm>
          <a:off x="17391" y="2954166"/>
          <a:ext cx="5856989" cy="60062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0211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50105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50211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35169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600627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700" i="1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</a:rPr>
                        <a:t>Admission</a:t>
                      </a:r>
                      <a:endParaRPr lang="ja-JP" sz="2000" i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114407" marR="114407" marT="0" marB="0" anchor="ctr"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ja-JP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114407" marR="114407" marT="0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endParaRPr lang="ja-JP" sz="2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114407" marR="114407" marT="0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700" i="1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</a:rPr>
                        <a:t>Discharge</a:t>
                      </a:r>
                      <a:endParaRPr lang="ja-JP" sz="2000" i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114407" marR="114407" marT="0" marB="0" anchor="ctr"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sp>
        <p:nvSpPr>
          <p:cNvPr id="29" name="直角三角形 28"/>
          <p:cNvSpPr/>
          <p:nvPr/>
        </p:nvSpPr>
        <p:spPr>
          <a:xfrm rot="10800000" flipV="1">
            <a:off x="3976800" y="2970468"/>
            <a:ext cx="537225" cy="557409"/>
          </a:xfrm>
          <a:prstGeom prst="rtTriangl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0" name="直角三角形 29"/>
          <p:cNvSpPr/>
          <p:nvPr/>
        </p:nvSpPr>
        <p:spPr>
          <a:xfrm flipV="1">
            <a:off x="1527894" y="2965138"/>
            <a:ext cx="554099" cy="562737"/>
          </a:xfrm>
          <a:prstGeom prst="rtTriangle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2" name="左中かっこ 31"/>
          <p:cNvSpPr/>
          <p:nvPr/>
        </p:nvSpPr>
        <p:spPr>
          <a:xfrm rot="16200000">
            <a:off x="2630391" y="2438707"/>
            <a:ext cx="205173" cy="2487648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35" name="正方形/長方形 34"/>
          <p:cNvSpPr/>
          <p:nvPr/>
        </p:nvSpPr>
        <p:spPr>
          <a:xfrm>
            <a:off x="2078246" y="3054424"/>
            <a:ext cx="166584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000" b="1" i="1" dirty="0">
                <a:solidFill>
                  <a:srgbClr val="FFC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Phase I CR</a:t>
            </a:r>
            <a:endParaRPr lang="ja-JP" altLang="en-US" sz="2000" b="1" i="1" dirty="0">
              <a:solidFill>
                <a:srgbClr val="FFC0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6" name="左中かっこ 35"/>
          <p:cNvSpPr/>
          <p:nvPr/>
        </p:nvSpPr>
        <p:spPr>
          <a:xfrm rot="5400000">
            <a:off x="3140872" y="1554115"/>
            <a:ext cx="310525" cy="2435779"/>
          </a:xfrm>
          <a:prstGeom prst="leftBrace">
            <a:avLst>
              <a:gd name="adj1" fmla="val 0"/>
              <a:gd name="adj2" fmla="val 5000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4" name="正方形/長方形 3"/>
          <p:cNvSpPr/>
          <p:nvPr/>
        </p:nvSpPr>
        <p:spPr>
          <a:xfrm>
            <a:off x="62364" y="6375542"/>
            <a:ext cx="22509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/>
              <a:t>Online Resource 1. </a:t>
            </a:r>
            <a:endParaRPr lang="ja-JP" altLang="en-US" dirty="0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8011" y="1608127"/>
            <a:ext cx="996063" cy="999394"/>
          </a:xfrm>
          <a:prstGeom prst="rect">
            <a:avLst/>
          </a:prstGeom>
        </p:spPr>
      </p:pic>
      <p:sp>
        <p:nvSpPr>
          <p:cNvPr id="48" name="上矢印 47"/>
          <p:cNvSpPr/>
          <p:nvPr/>
        </p:nvSpPr>
        <p:spPr>
          <a:xfrm rot="10800000">
            <a:off x="11153833" y="158434"/>
            <a:ext cx="490133" cy="662233"/>
          </a:xfrm>
          <a:prstGeom prst="up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上矢印 48"/>
          <p:cNvSpPr/>
          <p:nvPr/>
        </p:nvSpPr>
        <p:spPr>
          <a:xfrm>
            <a:off x="4456198" y="4157114"/>
            <a:ext cx="490133" cy="662233"/>
          </a:xfrm>
          <a:prstGeom prst="up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/>
          <p:cNvSpPr/>
          <p:nvPr/>
        </p:nvSpPr>
        <p:spPr>
          <a:xfrm rot="20659089">
            <a:off x="7759309" y="3040011"/>
            <a:ext cx="23711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i="1" dirty="0">
                <a:solidFill>
                  <a:srgbClr val="C00000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Activities of daily living</a:t>
            </a:r>
            <a:endParaRPr lang="ja-JP" altLang="en-US" sz="1400" b="1" i="1" dirty="0">
              <a:solidFill>
                <a:srgbClr val="C00000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623553" y="3540880"/>
            <a:ext cx="544130" cy="581145"/>
          </a:xfrm>
          <a:prstGeom prst="rect">
            <a:avLst/>
          </a:prstGeom>
        </p:spPr>
      </p:pic>
      <p:sp>
        <p:nvSpPr>
          <p:cNvPr id="64" name="上矢印 63"/>
          <p:cNvSpPr/>
          <p:nvPr/>
        </p:nvSpPr>
        <p:spPr>
          <a:xfrm rot="10800000">
            <a:off x="11153833" y="3013426"/>
            <a:ext cx="490133" cy="662233"/>
          </a:xfrm>
          <a:prstGeom prst="upArrow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8" name="図 1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495829" y="3452748"/>
            <a:ext cx="717205" cy="717205"/>
          </a:xfrm>
          <a:prstGeom prst="rect">
            <a:avLst/>
          </a:prstGeom>
        </p:spPr>
      </p:pic>
      <p:pic>
        <p:nvPicPr>
          <p:cNvPr id="33" name="図 3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45885" y="1771122"/>
            <a:ext cx="836399" cy="836399"/>
          </a:xfrm>
          <a:prstGeom prst="rect">
            <a:avLst/>
          </a:prstGeom>
        </p:spPr>
      </p:pic>
      <p:pic>
        <p:nvPicPr>
          <p:cNvPr id="34" name="図 3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68404" y="1668110"/>
            <a:ext cx="939411" cy="939411"/>
          </a:xfrm>
          <a:prstGeom prst="rect">
            <a:avLst/>
          </a:prstGeom>
        </p:spPr>
      </p:pic>
      <p:pic>
        <p:nvPicPr>
          <p:cNvPr id="43" name="図 4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85096" y="1786221"/>
            <a:ext cx="821300" cy="821300"/>
          </a:xfrm>
          <a:prstGeom prst="rect">
            <a:avLst/>
          </a:prstGeom>
        </p:spPr>
      </p:pic>
      <p:pic>
        <p:nvPicPr>
          <p:cNvPr id="1026" name="Picture 2" descr="歩いている人の白黒シルエットイラスト06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3315" y="3406501"/>
            <a:ext cx="796930" cy="7969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図 5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615838" y="1751090"/>
            <a:ext cx="856431" cy="856431"/>
          </a:xfrm>
          <a:prstGeom prst="rect">
            <a:avLst/>
          </a:prstGeom>
        </p:spPr>
      </p:pic>
      <p:pic>
        <p:nvPicPr>
          <p:cNvPr id="52" name="図 5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325021" y="4488231"/>
            <a:ext cx="762172" cy="762172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148060" y="4496339"/>
            <a:ext cx="990633" cy="754064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738402" y="447775"/>
            <a:ext cx="361807" cy="487722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504804" y="1768753"/>
            <a:ext cx="1397772" cy="784403"/>
          </a:xfrm>
          <a:prstGeom prst="rect">
            <a:avLst/>
          </a:prstGeom>
        </p:spPr>
      </p:pic>
      <p:pic>
        <p:nvPicPr>
          <p:cNvPr id="58" name="図 57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249579" y="1101658"/>
            <a:ext cx="2523986" cy="1514392"/>
          </a:xfrm>
          <a:prstGeom prst="rect">
            <a:avLst/>
          </a:prstGeom>
        </p:spPr>
      </p:pic>
      <p:sp>
        <p:nvSpPr>
          <p:cNvPr id="60" name="テキスト ボックス 59"/>
          <p:cNvSpPr txBox="1"/>
          <p:nvPr/>
        </p:nvSpPr>
        <p:spPr>
          <a:xfrm>
            <a:off x="9249580" y="1159516"/>
            <a:ext cx="5876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(sec)</a:t>
            </a:r>
            <a:endParaRPr kumimoji="1" lang="ja-JP" alt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6703939" y="1159516"/>
            <a:ext cx="7298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(m/sec)</a:t>
            </a:r>
            <a:endParaRPr kumimoji="1" lang="ja-JP" alt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7599660" y="1217396"/>
            <a:ext cx="906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＊</a:t>
            </a:r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10282886" y="1217396"/>
            <a:ext cx="906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＊</a:t>
            </a:r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</a:p>
        </p:txBody>
      </p:sp>
      <p:pic>
        <p:nvPicPr>
          <p:cNvPr id="71" name="図 70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560176" y="4268876"/>
            <a:ext cx="2563966" cy="1538380"/>
          </a:xfrm>
          <a:prstGeom prst="rect">
            <a:avLst/>
          </a:prstGeom>
        </p:spPr>
      </p:pic>
      <p:pic>
        <p:nvPicPr>
          <p:cNvPr id="73" name="図 72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9635888" y="4268876"/>
            <a:ext cx="2563966" cy="1538380"/>
          </a:xfrm>
          <a:prstGeom prst="rect">
            <a:avLst/>
          </a:prstGeom>
        </p:spPr>
      </p:pic>
      <p:sp>
        <p:nvSpPr>
          <p:cNvPr id="76" name="テキスト ボックス 75"/>
          <p:cNvSpPr txBox="1"/>
          <p:nvPr/>
        </p:nvSpPr>
        <p:spPr>
          <a:xfrm>
            <a:off x="5512528" y="4262181"/>
            <a:ext cx="7298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(Points</a:t>
            </a:r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  <a:endParaRPr kumimoji="1" lang="ja-JP" alt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7687903" y="4262181"/>
            <a:ext cx="7298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(Points</a:t>
            </a:r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  <a:endParaRPr kumimoji="1" lang="ja-JP" alt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9759206" y="4262181"/>
            <a:ext cx="7298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(Points</a:t>
            </a:r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  <a:endParaRPr kumimoji="1" lang="ja-JP" altLang="en-US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6285792" y="4395707"/>
            <a:ext cx="906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＊</a:t>
            </a:r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8587083" y="4395707"/>
            <a:ext cx="906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＊</a:t>
            </a:r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10620570" y="4395707"/>
            <a:ext cx="9063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＊</a:t>
            </a:r>
            <a:r>
              <a:rPr kumimoji="1" lang="en-US" altLang="ja-JP" sz="1000" dirty="0">
                <a:latin typeface="Calibri" panose="020F0502020204030204" pitchFamily="34" charset="0"/>
                <a:cs typeface="Calibri" panose="020F0502020204030204" pitchFamily="34" charset="0"/>
              </a:rPr>
              <a:t>&lt;0.001</a:t>
            </a:r>
          </a:p>
        </p:txBody>
      </p:sp>
      <p:cxnSp>
        <p:nvCxnSpPr>
          <p:cNvPr id="11" name="カギ線コネクタ 10"/>
          <p:cNvCxnSpPr/>
          <p:nvPr/>
        </p:nvCxnSpPr>
        <p:spPr>
          <a:xfrm>
            <a:off x="5671359" y="2772005"/>
            <a:ext cx="836395" cy="421894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40767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8</TotalTime>
  <Words>139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Meiryo UI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島 侑司</dc:creator>
  <cp:lastModifiedBy>Asha Mol S P Sadasivan P</cp:lastModifiedBy>
  <cp:revision>129</cp:revision>
  <dcterms:created xsi:type="dcterms:W3CDTF">2021-07-06T20:46:35Z</dcterms:created>
  <dcterms:modified xsi:type="dcterms:W3CDTF">2024-06-15T09:35:32Z</dcterms:modified>
</cp:coreProperties>
</file>